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  <p:sldMasterId id="2147483684" r:id="rId2"/>
  </p:sldMasterIdLst>
  <p:notesMasterIdLst>
    <p:notesMasterId r:id="rId5"/>
  </p:notesMasterIdLst>
  <p:handoutMasterIdLst>
    <p:handoutMasterId r:id="rId6"/>
  </p:handoutMasterIdLst>
  <p:sldIdLst>
    <p:sldId id="280" r:id="rId3"/>
    <p:sldId id="282" r:id="rId4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524" autoAdjust="0"/>
    <p:restoredTop sz="94660"/>
  </p:normalViewPr>
  <p:slideViewPr>
    <p:cSldViewPr snapToGrid="0">
      <p:cViewPr varScale="1">
        <p:scale>
          <a:sx n="76" d="100"/>
          <a:sy n="76" d="100"/>
        </p:scale>
        <p:origin x="-1992" y="-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-155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6AB1A0-7977-4042-B20A-D02F29FF5770}" type="datetimeFigureOut">
              <a:rPr lang="en-GB" smtClean="0"/>
              <a:t>02/06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EAA27B-0B21-4E04-8655-DFC9EC8EAA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047771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0345A0-B021-4CBD-AD66-1394D9D6C2AC}" type="datetimeFigureOut">
              <a:rPr lang="en-GB" smtClean="0"/>
              <a:t>02/06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B58E98-5048-4873-A46A-4F4CB52CDC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33450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18A20-CFE6-49D1-BABD-E6033C8725FB}" type="datetimeFigureOut">
              <a:rPr lang="en-GB" smtClean="0"/>
              <a:t>02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2BD29-19BE-4BB0-894F-BC46932FD7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81095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18A20-CFE6-49D1-BABD-E6033C8725FB}" type="datetimeFigureOut">
              <a:rPr lang="en-GB" smtClean="0"/>
              <a:t>02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2BD29-19BE-4BB0-894F-BC46932FD7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4375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18A20-CFE6-49D1-BABD-E6033C8725FB}" type="datetimeFigureOut">
              <a:rPr lang="en-GB" smtClean="0"/>
              <a:t>02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2BD29-19BE-4BB0-894F-BC46932FD7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166547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/2018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78932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18A20-CFE6-49D1-BABD-E6033C8725FB}" type="datetimeFigureOut">
              <a:rPr lang="en-GB" smtClean="0"/>
              <a:t>02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2BD29-19BE-4BB0-894F-BC46932FD7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52098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18A20-CFE6-49D1-BABD-E6033C8725FB}" type="datetimeFigureOut">
              <a:rPr lang="en-GB" smtClean="0"/>
              <a:t>02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2BD29-19BE-4BB0-894F-BC46932FD7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97745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18A20-CFE6-49D1-BABD-E6033C8725FB}" type="datetimeFigureOut">
              <a:rPr lang="en-GB" smtClean="0"/>
              <a:t>02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2BD29-19BE-4BB0-894F-BC46932FD7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59628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18A20-CFE6-49D1-BABD-E6033C8725FB}" type="datetimeFigureOut">
              <a:rPr lang="en-GB" smtClean="0"/>
              <a:t>02/06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2BD29-19BE-4BB0-894F-BC46932FD7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03011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18A20-CFE6-49D1-BABD-E6033C8725FB}" type="datetimeFigureOut">
              <a:rPr lang="en-GB" smtClean="0"/>
              <a:t>02/06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2BD29-19BE-4BB0-894F-BC46932FD7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41797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18A20-CFE6-49D1-BABD-E6033C8725FB}" type="datetimeFigureOut">
              <a:rPr lang="en-GB" smtClean="0"/>
              <a:t>02/06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2BD29-19BE-4BB0-894F-BC46932FD7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60660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18A20-CFE6-49D1-BABD-E6033C8725FB}" type="datetimeFigureOut">
              <a:rPr lang="en-GB" smtClean="0"/>
              <a:t>02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2BD29-19BE-4BB0-894F-BC46932FD7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6455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18A20-CFE6-49D1-BABD-E6033C8725FB}" type="datetimeFigureOut">
              <a:rPr lang="en-GB" smtClean="0"/>
              <a:t>02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2BD29-19BE-4BB0-894F-BC46932FD7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35787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2" Type="http://schemas.openxmlformats.org/officeDocument/2006/relationships/theme" Target="../theme/theme2.xml"/><Relationship Id="rId1" Type="http://schemas.openxmlformats.org/officeDocument/2006/relationships/slideLayout" Target="../slideLayouts/slideLayout1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D18A20-CFE6-49D1-BABD-E6033C8725FB}" type="datetimeFigureOut">
              <a:rPr lang="en-GB" smtClean="0"/>
              <a:t>02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32BD29-19BE-4BB0-894F-BC46932FD7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48628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A97C-6094-44F3-9AD2-0A11796E8BE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/2018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88D163-8FEE-4B6A-977D-600E3843CE6C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35993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5" name="Straight Connector 14"/>
          <p:cNvCxnSpPr/>
          <p:nvPr/>
        </p:nvCxnSpPr>
        <p:spPr>
          <a:xfrm>
            <a:off x="2218448" y="4889609"/>
            <a:ext cx="922866" cy="0"/>
          </a:xfrm>
          <a:prstGeom prst="line">
            <a:avLst/>
          </a:prstGeom>
          <a:ln w="190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Connector 164"/>
          <p:cNvCxnSpPr/>
          <p:nvPr/>
        </p:nvCxnSpPr>
        <p:spPr>
          <a:xfrm>
            <a:off x="2218448" y="4500142"/>
            <a:ext cx="922866" cy="0"/>
          </a:xfrm>
          <a:prstGeom prst="line">
            <a:avLst/>
          </a:prstGeom>
          <a:ln w="190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6" name="Straight Connector 165"/>
          <p:cNvCxnSpPr/>
          <p:nvPr/>
        </p:nvCxnSpPr>
        <p:spPr>
          <a:xfrm>
            <a:off x="2218448" y="5423009"/>
            <a:ext cx="922866" cy="0"/>
          </a:xfrm>
          <a:prstGeom prst="line">
            <a:avLst/>
          </a:prstGeom>
          <a:ln w="190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Right Arrow 3"/>
          <p:cNvSpPr/>
          <p:nvPr/>
        </p:nvSpPr>
        <p:spPr>
          <a:xfrm>
            <a:off x="2144496" y="2329714"/>
            <a:ext cx="304800" cy="228600"/>
          </a:xfrm>
          <a:prstGeom prst="rightArrow">
            <a:avLst>
              <a:gd name="adj1" fmla="val 70513"/>
              <a:gd name="adj2" fmla="val 56837"/>
            </a:avLst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>
              <a:solidFill>
                <a:prstClr val="white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Right Arrow 4"/>
          <p:cNvSpPr/>
          <p:nvPr/>
        </p:nvSpPr>
        <p:spPr>
          <a:xfrm>
            <a:off x="2449296" y="2329714"/>
            <a:ext cx="1712569" cy="228600"/>
          </a:xfrm>
          <a:prstGeom prst="rightArrow">
            <a:avLst>
              <a:gd name="adj1" fmla="val 70513"/>
              <a:gd name="adj2" fmla="val 56837"/>
            </a:avLst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>
              <a:solidFill>
                <a:prstClr val="white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Right Arrow 5"/>
          <p:cNvSpPr/>
          <p:nvPr/>
        </p:nvSpPr>
        <p:spPr>
          <a:xfrm>
            <a:off x="2144496" y="2671034"/>
            <a:ext cx="304800" cy="228600"/>
          </a:xfrm>
          <a:prstGeom prst="rightArrow">
            <a:avLst>
              <a:gd name="adj1" fmla="val 70513"/>
              <a:gd name="adj2" fmla="val 56837"/>
            </a:avLst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>
              <a:solidFill>
                <a:prstClr val="white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Right Arrow 6"/>
          <p:cNvSpPr/>
          <p:nvPr/>
        </p:nvSpPr>
        <p:spPr>
          <a:xfrm>
            <a:off x="2449296" y="2671034"/>
            <a:ext cx="1046785" cy="228600"/>
          </a:xfrm>
          <a:prstGeom prst="rightArrow">
            <a:avLst>
              <a:gd name="adj1" fmla="val 70513"/>
              <a:gd name="adj2" fmla="val 56837"/>
            </a:avLst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>
              <a:solidFill>
                <a:prstClr val="white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Right Arrow 7"/>
          <p:cNvSpPr/>
          <p:nvPr/>
        </p:nvSpPr>
        <p:spPr>
          <a:xfrm>
            <a:off x="2149243" y="3020648"/>
            <a:ext cx="304800" cy="228600"/>
          </a:xfrm>
          <a:prstGeom prst="rightArrow">
            <a:avLst>
              <a:gd name="adj1" fmla="val 70513"/>
              <a:gd name="adj2" fmla="val 56837"/>
            </a:avLst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>
              <a:solidFill>
                <a:prstClr val="white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Right Arrow 8"/>
          <p:cNvSpPr/>
          <p:nvPr/>
        </p:nvSpPr>
        <p:spPr>
          <a:xfrm>
            <a:off x="2454043" y="3020648"/>
            <a:ext cx="756031" cy="228600"/>
          </a:xfrm>
          <a:prstGeom prst="rightArrow">
            <a:avLst>
              <a:gd name="adj1" fmla="val 70513"/>
              <a:gd name="adj2" fmla="val 56837"/>
            </a:avLst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>
              <a:solidFill>
                <a:prstClr val="white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Right Arrow 9"/>
          <p:cNvSpPr/>
          <p:nvPr/>
        </p:nvSpPr>
        <p:spPr>
          <a:xfrm>
            <a:off x="2149243" y="3391465"/>
            <a:ext cx="304800" cy="228600"/>
          </a:xfrm>
          <a:prstGeom prst="rightArrow">
            <a:avLst>
              <a:gd name="adj1" fmla="val 70513"/>
              <a:gd name="adj2" fmla="val 56837"/>
            </a:avLst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>
              <a:solidFill>
                <a:prstClr val="white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Right Arrow 10"/>
          <p:cNvSpPr/>
          <p:nvPr/>
        </p:nvSpPr>
        <p:spPr>
          <a:xfrm>
            <a:off x="2454043" y="3391465"/>
            <a:ext cx="646472" cy="228600"/>
          </a:xfrm>
          <a:prstGeom prst="rightArrow">
            <a:avLst>
              <a:gd name="adj1" fmla="val 70513"/>
              <a:gd name="adj2" fmla="val 56837"/>
            </a:avLst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>
              <a:solidFill>
                <a:prstClr val="white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665960" y="2299548"/>
            <a:ext cx="1129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L </a:t>
            </a:r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(polymerase)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741812" y="264508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NP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481078" y="2998910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VP35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422082" y="3369726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VP30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071814" y="2653845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T7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071814" y="2308311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T7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2076561" y="3003458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T7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076561" y="3374275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T7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1245905" y="2300219"/>
            <a:ext cx="5533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T7-L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1245905" y="2658394"/>
            <a:ext cx="6719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T7-NP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1250652" y="3003795"/>
            <a:ext cx="8210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T7-VP35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1250652" y="3370397"/>
            <a:ext cx="8210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T7-VP30</a:t>
            </a:r>
          </a:p>
        </p:txBody>
      </p:sp>
      <p:sp>
        <p:nvSpPr>
          <p:cNvPr id="37" name="Right Arrow 36"/>
          <p:cNvSpPr/>
          <p:nvPr/>
        </p:nvSpPr>
        <p:spPr>
          <a:xfrm flipH="1">
            <a:off x="3143821" y="4381942"/>
            <a:ext cx="304800" cy="228600"/>
          </a:xfrm>
          <a:prstGeom prst="rightArrow">
            <a:avLst>
              <a:gd name="adj1" fmla="val 70513"/>
              <a:gd name="adj2" fmla="val 56837"/>
            </a:avLst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>
              <a:solidFill>
                <a:prstClr val="white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Right Arrow 37"/>
          <p:cNvSpPr/>
          <p:nvPr/>
        </p:nvSpPr>
        <p:spPr>
          <a:xfrm>
            <a:off x="2306305" y="4381942"/>
            <a:ext cx="733169" cy="228600"/>
          </a:xfrm>
          <a:prstGeom prst="rightArrow">
            <a:avLst>
              <a:gd name="adj1" fmla="val 70513"/>
              <a:gd name="adj2" fmla="val 56837"/>
            </a:avLst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>
              <a:solidFill>
                <a:prstClr val="white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1840779" y="4410729"/>
            <a:ext cx="375030" cy="168553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>
              <a:solidFill>
                <a:prstClr val="white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 rot="10800000" flipH="1">
            <a:off x="2376035" y="4363337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F-</a:t>
            </a:r>
            <a:r>
              <a:rPr lang="en-GB" sz="1200" dirty="0" err="1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luc</a:t>
            </a:r>
            <a:endParaRPr lang="en-GB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 flipH="1">
            <a:off x="3151453" y="4352447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T7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1765385" y="4369848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T7t/</a:t>
            </a:r>
            <a:r>
              <a:rPr lang="en-GB" sz="9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Rz</a:t>
            </a:r>
            <a:endParaRPr lang="en-GB" sz="9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736713" y="4346092"/>
            <a:ext cx="8723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err="1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MG-FLuc</a:t>
            </a:r>
            <a:endParaRPr lang="en-GB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Arc 48"/>
          <p:cNvSpPr/>
          <p:nvPr/>
        </p:nvSpPr>
        <p:spPr>
          <a:xfrm>
            <a:off x="3315047" y="4475272"/>
            <a:ext cx="675051" cy="948267"/>
          </a:xfrm>
          <a:prstGeom prst="arc">
            <a:avLst>
              <a:gd name="adj1" fmla="val 16200000"/>
              <a:gd name="adj2" fmla="val 5855441"/>
            </a:avLst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60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Right Arrow 49"/>
          <p:cNvSpPr/>
          <p:nvPr/>
        </p:nvSpPr>
        <p:spPr>
          <a:xfrm>
            <a:off x="2314772" y="5301298"/>
            <a:ext cx="733169" cy="228600"/>
          </a:xfrm>
          <a:prstGeom prst="rightArrow">
            <a:avLst>
              <a:gd name="adj1" fmla="val 70513"/>
              <a:gd name="adj2" fmla="val 56837"/>
            </a:avLst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>
              <a:solidFill>
                <a:prstClr val="white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 rot="10800000" flipH="1">
            <a:off x="2358854" y="5282693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F-Luc</a:t>
            </a:r>
            <a:endParaRPr lang="en-GB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3085620" y="5280791"/>
            <a:ext cx="2952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5’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2008805" y="5280791"/>
            <a:ext cx="2952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3’</a:t>
            </a:r>
          </a:p>
        </p:txBody>
      </p:sp>
      <p:sp>
        <p:nvSpPr>
          <p:cNvPr id="58" name="TextBox 57"/>
          <p:cNvSpPr txBox="1"/>
          <p:nvPr/>
        </p:nvSpPr>
        <p:spPr>
          <a:xfrm flipH="1">
            <a:off x="2157935" y="5984995"/>
            <a:ext cx="10995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F-Luc </a:t>
            </a:r>
            <a:r>
              <a: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RNA</a:t>
            </a:r>
            <a:endParaRPr lang="en-GB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3085620" y="5804122"/>
            <a:ext cx="2952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3’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2008805" y="5804122"/>
            <a:ext cx="2952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5’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4008558" y="4669767"/>
            <a:ext cx="1750217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T7 </a:t>
            </a:r>
            <a:r>
              <a:rPr lang="en-GB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rimary </a:t>
            </a:r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transcription</a:t>
            </a:r>
          </a:p>
          <a:p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(T7 RNA polymerase </a:t>
            </a:r>
            <a:r>
              <a:rPr lang="en-GB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/>
            </a:r>
            <a:br>
              <a:rPr lang="en-GB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</a:br>
            <a:r>
              <a:rPr lang="en-GB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expressing </a:t>
            </a:r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ells)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311646" y="5006319"/>
            <a:ext cx="172194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olymerase complex</a:t>
            </a:r>
          </a:p>
          <a:p>
            <a:pPr algn="ctr"/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(L + NP + VP35 + VP30)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1740173" y="6313520"/>
            <a:ext cx="8835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Translation</a:t>
            </a:r>
          </a:p>
        </p:txBody>
      </p:sp>
      <p:sp>
        <p:nvSpPr>
          <p:cNvPr id="71" name="Oval 70"/>
          <p:cNvSpPr/>
          <p:nvPr/>
        </p:nvSpPr>
        <p:spPr>
          <a:xfrm>
            <a:off x="2340132" y="6651204"/>
            <a:ext cx="711882" cy="270934"/>
          </a:xfrm>
          <a:prstGeom prst="ellipse">
            <a:avLst/>
          </a:prstGeom>
          <a:solidFill>
            <a:srgbClr val="FFFF00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>
              <a:solidFill>
                <a:prstClr val="white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 flipH="1">
            <a:off x="2399235" y="6638059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F-Luc</a:t>
            </a:r>
            <a:endParaRPr lang="en-GB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3022161" y="6648921"/>
            <a:ext cx="22273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Firefly luciferase</a:t>
            </a:r>
            <a:endParaRPr lang="en-GB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2316341" y="5906027"/>
            <a:ext cx="720000" cy="72084"/>
            <a:chOff x="2574396" y="6032383"/>
            <a:chExt cx="497097" cy="72084"/>
          </a:xfrm>
        </p:grpSpPr>
        <p:sp>
          <p:nvSpPr>
            <p:cNvPr id="157" name="Freeform 156"/>
            <p:cNvSpPr/>
            <p:nvPr/>
          </p:nvSpPr>
          <p:spPr>
            <a:xfrm>
              <a:off x="2603494" y="6032383"/>
              <a:ext cx="467999" cy="65492"/>
            </a:xfrm>
            <a:custGeom>
              <a:avLst/>
              <a:gdLst>
                <a:gd name="connsiteX0" fmla="*/ 0 w 495300"/>
                <a:gd name="connsiteY0" fmla="*/ 42449 h 65492"/>
                <a:gd name="connsiteX1" fmla="*/ 156634 w 495300"/>
                <a:gd name="connsiteY1" fmla="*/ 63616 h 65492"/>
                <a:gd name="connsiteX2" fmla="*/ 334434 w 495300"/>
                <a:gd name="connsiteY2" fmla="*/ 116 h 65492"/>
                <a:gd name="connsiteX3" fmla="*/ 495300 w 495300"/>
                <a:gd name="connsiteY3" fmla="*/ 46683 h 6549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95300" h="65492">
                  <a:moveTo>
                    <a:pt x="0" y="42449"/>
                  </a:moveTo>
                  <a:cubicBezTo>
                    <a:pt x="50447" y="56560"/>
                    <a:pt x="100895" y="70671"/>
                    <a:pt x="156634" y="63616"/>
                  </a:cubicBezTo>
                  <a:cubicBezTo>
                    <a:pt x="212373" y="56561"/>
                    <a:pt x="277990" y="2938"/>
                    <a:pt x="334434" y="116"/>
                  </a:cubicBezTo>
                  <a:cubicBezTo>
                    <a:pt x="390878" y="-2706"/>
                    <a:pt x="495300" y="46683"/>
                    <a:pt x="495300" y="46683"/>
                  </a:cubicBezTo>
                </a:path>
              </a:pathLst>
            </a:custGeom>
            <a:ln w="1905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158" name="Oval 157"/>
            <p:cNvSpPr/>
            <p:nvPr/>
          </p:nvSpPr>
          <p:spPr>
            <a:xfrm>
              <a:off x="2574396" y="6053667"/>
              <a:ext cx="46566" cy="50800"/>
            </a:xfrm>
            <a:prstGeom prst="ellipse">
              <a:avLst/>
            </a:prstGeom>
            <a:solidFill>
              <a:schemeClr val="tx1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prstClr val="white"/>
                </a:solidFill>
              </a:endParaRPr>
            </a:p>
          </p:txBody>
        </p:sp>
      </p:grpSp>
      <p:cxnSp>
        <p:nvCxnSpPr>
          <p:cNvPr id="159" name="Straight Arrow Connector 158"/>
          <p:cNvCxnSpPr/>
          <p:nvPr/>
        </p:nvCxnSpPr>
        <p:spPr>
          <a:xfrm>
            <a:off x="2683402" y="6272848"/>
            <a:ext cx="0" cy="359997"/>
          </a:xfrm>
          <a:prstGeom prst="straightConnector1">
            <a:avLst/>
          </a:prstGeom>
          <a:ln w="28575" cmpd="sng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" name="Group 12"/>
          <p:cNvGrpSpPr/>
          <p:nvPr/>
        </p:nvGrpSpPr>
        <p:grpSpPr>
          <a:xfrm rot="10800000">
            <a:off x="2297838" y="4744337"/>
            <a:ext cx="733169" cy="276999"/>
            <a:chOff x="2492390" y="4841065"/>
            <a:chExt cx="733169" cy="276999"/>
          </a:xfrm>
        </p:grpSpPr>
        <p:sp>
          <p:nvSpPr>
            <p:cNvPr id="161" name="Right Arrow 160"/>
            <p:cNvSpPr/>
            <p:nvPr/>
          </p:nvSpPr>
          <p:spPr>
            <a:xfrm>
              <a:off x="2492390" y="4859671"/>
              <a:ext cx="733169" cy="228600"/>
            </a:xfrm>
            <a:prstGeom prst="rightArrow">
              <a:avLst>
                <a:gd name="adj1" fmla="val 70513"/>
                <a:gd name="adj2" fmla="val 56837"/>
              </a:avLst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00">
                <a:solidFill>
                  <a:prstClr val="white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2" name="TextBox 161"/>
            <p:cNvSpPr txBox="1"/>
            <p:nvPr/>
          </p:nvSpPr>
          <p:spPr>
            <a:xfrm rot="10800000" flipH="1">
              <a:off x="2549297" y="4841065"/>
              <a:ext cx="5774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F-Luc</a:t>
              </a:r>
              <a:endPara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63" name="TextBox 162"/>
          <p:cNvSpPr txBox="1"/>
          <p:nvPr/>
        </p:nvSpPr>
        <p:spPr>
          <a:xfrm>
            <a:off x="2008805" y="4730457"/>
            <a:ext cx="2952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5’</a:t>
            </a:r>
          </a:p>
        </p:txBody>
      </p:sp>
      <p:sp>
        <p:nvSpPr>
          <p:cNvPr id="164" name="TextBox 163"/>
          <p:cNvSpPr txBox="1"/>
          <p:nvPr/>
        </p:nvSpPr>
        <p:spPr>
          <a:xfrm>
            <a:off x="3085620" y="4738924"/>
            <a:ext cx="2952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3’</a:t>
            </a:r>
          </a:p>
        </p:txBody>
      </p:sp>
      <p:cxnSp>
        <p:nvCxnSpPr>
          <p:cNvPr id="167" name="Straight Arrow Connector 166"/>
          <p:cNvCxnSpPr/>
          <p:nvPr/>
        </p:nvCxnSpPr>
        <p:spPr>
          <a:xfrm>
            <a:off x="2141534" y="5553182"/>
            <a:ext cx="0" cy="287997"/>
          </a:xfrm>
          <a:prstGeom prst="straightConnector1">
            <a:avLst/>
          </a:prstGeom>
          <a:ln w="28575" cmpd="sng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Straight Arrow Connector 167"/>
          <p:cNvCxnSpPr/>
          <p:nvPr/>
        </p:nvCxnSpPr>
        <p:spPr>
          <a:xfrm>
            <a:off x="3225267" y="5002848"/>
            <a:ext cx="0" cy="287997"/>
          </a:xfrm>
          <a:prstGeom prst="straightConnector1">
            <a:avLst/>
          </a:prstGeom>
          <a:ln w="28575" cmpd="sng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Arrow Connector 168"/>
          <p:cNvCxnSpPr/>
          <p:nvPr/>
        </p:nvCxnSpPr>
        <p:spPr>
          <a:xfrm flipV="1">
            <a:off x="2141534" y="4994381"/>
            <a:ext cx="0" cy="287997"/>
          </a:xfrm>
          <a:prstGeom prst="straightConnector1">
            <a:avLst/>
          </a:prstGeom>
          <a:ln w="28575" cmpd="sng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4" name="Group 13"/>
          <p:cNvGrpSpPr/>
          <p:nvPr/>
        </p:nvGrpSpPr>
        <p:grpSpPr>
          <a:xfrm>
            <a:off x="4113753" y="2321336"/>
            <a:ext cx="473206" cy="230832"/>
            <a:chOff x="4156737" y="2305706"/>
            <a:chExt cx="473206" cy="230832"/>
          </a:xfrm>
        </p:grpSpPr>
        <p:sp>
          <p:nvSpPr>
            <p:cNvPr id="160" name="Rectangle 159"/>
            <p:cNvSpPr/>
            <p:nvPr/>
          </p:nvSpPr>
          <p:spPr>
            <a:xfrm>
              <a:off x="4221300" y="2356055"/>
              <a:ext cx="346792" cy="140960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463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1" name="TextBox 170"/>
            <p:cNvSpPr txBox="1"/>
            <p:nvPr/>
          </p:nvSpPr>
          <p:spPr>
            <a:xfrm>
              <a:off x="4156737" y="2305706"/>
              <a:ext cx="4732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err="1">
                  <a:latin typeface="Arial" pitchFamily="34" charset="0"/>
                  <a:cs typeface="Arial" pitchFamily="34" charset="0"/>
                </a:rPr>
                <a:t>polyA</a:t>
              </a:r>
              <a:endParaRPr lang="en-GB" sz="9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72" name="Group 171"/>
          <p:cNvGrpSpPr/>
          <p:nvPr/>
        </p:nvGrpSpPr>
        <p:grpSpPr>
          <a:xfrm>
            <a:off x="3449446" y="2665213"/>
            <a:ext cx="473206" cy="230832"/>
            <a:chOff x="4156737" y="2305706"/>
            <a:chExt cx="473206" cy="230832"/>
          </a:xfrm>
        </p:grpSpPr>
        <p:sp>
          <p:nvSpPr>
            <p:cNvPr id="173" name="Rectangle 172"/>
            <p:cNvSpPr/>
            <p:nvPr/>
          </p:nvSpPr>
          <p:spPr>
            <a:xfrm>
              <a:off x="4221300" y="2356055"/>
              <a:ext cx="346792" cy="140960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463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4" name="TextBox 173"/>
            <p:cNvSpPr txBox="1"/>
            <p:nvPr/>
          </p:nvSpPr>
          <p:spPr>
            <a:xfrm>
              <a:off x="4156737" y="2305706"/>
              <a:ext cx="4732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err="1">
                  <a:latin typeface="Arial" pitchFamily="34" charset="0"/>
                  <a:cs typeface="Arial" pitchFamily="34" charset="0"/>
                </a:rPr>
                <a:t>polyA</a:t>
              </a:r>
              <a:endParaRPr lang="en-GB" sz="9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75" name="Group 174"/>
          <p:cNvGrpSpPr/>
          <p:nvPr/>
        </p:nvGrpSpPr>
        <p:grpSpPr>
          <a:xfrm>
            <a:off x="3160277" y="3020813"/>
            <a:ext cx="473206" cy="230832"/>
            <a:chOff x="4156737" y="2305706"/>
            <a:chExt cx="473206" cy="230832"/>
          </a:xfrm>
        </p:grpSpPr>
        <p:sp>
          <p:nvSpPr>
            <p:cNvPr id="176" name="Rectangle 175"/>
            <p:cNvSpPr/>
            <p:nvPr/>
          </p:nvSpPr>
          <p:spPr>
            <a:xfrm>
              <a:off x="4221300" y="2356055"/>
              <a:ext cx="346792" cy="140960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463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4156737" y="2305706"/>
              <a:ext cx="4732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err="1">
                  <a:latin typeface="Arial" pitchFamily="34" charset="0"/>
                  <a:cs typeface="Arial" pitchFamily="34" charset="0"/>
                </a:rPr>
                <a:t>polyA</a:t>
              </a:r>
              <a:endParaRPr lang="en-GB" sz="9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78" name="Group 177"/>
          <p:cNvGrpSpPr/>
          <p:nvPr/>
        </p:nvGrpSpPr>
        <p:grpSpPr>
          <a:xfrm>
            <a:off x="3050862" y="3376413"/>
            <a:ext cx="473206" cy="230832"/>
            <a:chOff x="4156737" y="2305706"/>
            <a:chExt cx="473206" cy="230832"/>
          </a:xfrm>
        </p:grpSpPr>
        <p:sp>
          <p:nvSpPr>
            <p:cNvPr id="179" name="Rectangle 178"/>
            <p:cNvSpPr/>
            <p:nvPr/>
          </p:nvSpPr>
          <p:spPr>
            <a:xfrm>
              <a:off x="4221300" y="2356055"/>
              <a:ext cx="346792" cy="140960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463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4156737" y="2305706"/>
              <a:ext cx="4732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err="1">
                  <a:latin typeface="Arial" pitchFamily="34" charset="0"/>
                  <a:cs typeface="Arial" pitchFamily="34" charset="0"/>
                </a:rPr>
                <a:t>polyA</a:t>
              </a:r>
              <a:endParaRPr lang="en-GB" sz="9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81" name="TextBox 180"/>
          <p:cNvSpPr txBox="1"/>
          <p:nvPr/>
        </p:nvSpPr>
        <p:spPr>
          <a:xfrm>
            <a:off x="878582" y="228068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</a:t>
            </a:r>
            <a:endParaRPr lang="en-GB" sz="14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82" name="TextBox 181"/>
          <p:cNvSpPr txBox="1"/>
          <p:nvPr/>
        </p:nvSpPr>
        <p:spPr>
          <a:xfrm>
            <a:off x="878582" y="398756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B</a:t>
            </a:r>
            <a:endParaRPr lang="en-GB" sz="14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29577" y="9321800"/>
            <a:ext cx="2521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>
            <a:alpha val="0"/>
          </a:srgb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78488558"/>
              </p:ext>
            </p:extLst>
          </p:nvPr>
        </p:nvGraphicFramePr>
        <p:xfrm>
          <a:off x="338139" y="4359276"/>
          <a:ext cx="6257925" cy="3227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591" name="Prism 7" r:id="rId3" imgW="4578405" imgH="2491185" progId="Prism7.Document">
                  <p:embed/>
                </p:oleObj>
              </mc:Choice>
              <mc:Fallback>
                <p:oleObj name="Prism 7" r:id="rId3" imgW="4578405" imgH="249118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38139" y="4359276"/>
                        <a:ext cx="6257925" cy="3227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Left Brace 2"/>
          <p:cNvSpPr/>
          <p:nvPr/>
        </p:nvSpPr>
        <p:spPr>
          <a:xfrm rot="5400000">
            <a:off x="1695453" y="4676820"/>
            <a:ext cx="45719" cy="331829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Left Brace 3"/>
          <p:cNvSpPr/>
          <p:nvPr/>
        </p:nvSpPr>
        <p:spPr>
          <a:xfrm rot="5400000">
            <a:off x="2923020" y="4664945"/>
            <a:ext cx="45719" cy="331829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Left Brace 4"/>
          <p:cNvSpPr/>
          <p:nvPr/>
        </p:nvSpPr>
        <p:spPr>
          <a:xfrm rot="5400000">
            <a:off x="4245586" y="4664945"/>
            <a:ext cx="45719" cy="331829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Left Brace 5"/>
          <p:cNvSpPr/>
          <p:nvPr/>
        </p:nvSpPr>
        <p:spPr>
          <a:xfrm rot="5400000">
            <a:off x="1900377" y="4768762"/>
            <a:ext cx="45720" cy="741679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Left Brace 6"/>
          <p:cNvSpPr/>
          <p:nvPr/>
        </p:nvSpPr>
        <p:spPr>
          <a:xfrm rot="5400000">
            <a:off x="3128316" y="4768389"/>
            <a:ext cx="45719" cy="742422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Left Brace 7"/>
          <p:cNvSpPr/>
          <p:nvPr/>
        </p:nvSpPr>
        <p:spPr>
          <a:xfrm rot="5400000">
            <a:off x="4462846" y="4756426"/>
            <a:ext cx="45722" cy="766352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TextBox 9"/>
          <p:cNvSpPr txBox="1"/>
          <p:nvPr/>
        </p:nvSpPr>
        <p:spPr>
          <a:xfrm>
            <a:off x="173892" y="9341338"/>
            <a:ext cx="2521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57223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blan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090</TotalTime>
  <Words>69</Words>
  <Application>Microsoft Office PowerPoint</Application>
  <PresentationFormat>A4 Paper (210x297 mm)</PresentationFormat>
  <Paragraphs>40</Paragraphs>
  <Slides>2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2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Office Theme</vt:lpstr>
      <vt:lpstr>blank</vt:lpstr>
      <vt:lpstr>Prism 7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Mohamed Habil P H.</cp:lastModifiedBy>
  <cp:revision>1</cp:revision>
  <cp:lastPrinted>2017-10-12T13:31:19Z</cp:lastPrinted>
  <dcterms:modified xsi:type="dcterms:W3CDTF">2018-06-02T07:39:38Z</dcterms:modified>
</cp:coreProperties>
</file>